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8415000" cy="12547600"/>
  <p:notesSz cx="18415000" cy="125476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8" d="100"/>
          <a:sy n="58" d="100"/>
        </p:scale>
        <p:origin x="1392" y="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62" d="100"/>
          <a:sy n="62" d="100"/>
        </p:scale>
        <p:origin x="2064" y="6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7980363" cy="628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10431463" y="0"/>
            <a:ext cx="7978775" cy="628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AB917B-B620-4915-9DE6-D7B133EB7904}" type="datetimeFigureOut">
              <a:rPr lang="ko-KR" altLang="en-US" smtClean="0"/>
              <a:t>2024-10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099175" y="1568450"/>
            <a:ext cx="6216650" cy="4235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1841500" y="6038850"/>
            <a:ext cx="14732000" cy="49403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11918950"/>
            <a:ext cx="7980363" cy="628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10431463" y="11918950"/>
            <a:ext cx="7978775" cy="628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F9D8A2-6A54-4C57-B2C6-346FCB9AB3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602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1381125" y="3889756"/>
            <a:ext cx="15652750" cy="263499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2762250" y="7026656"/>
            <a:ext cx="12890500" cy="3136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1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1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920750" y="2885948"/>
            <a:ext cx="8010525" cy="82814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9483725" y="2885948"/>
            <a:ext cx="8010525" cy="82814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1/2024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1/2024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1/2024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942921" y="408286"/>
            <a:ext cx="16573500" cy="20076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920750" y="2885948"/>
            <a:ext cx="16573500" cy="82814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 dirty="0"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6261100" y="11669268"/>
            <a:ext cx="5892800" cy="6273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920750" y="11669268"/>
            <a:ext cx="4235450" cy="6273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21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13258801" y="11669268"/>
            <a:ext cx="4235450" cy="6273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그룹 25"/>
          <p:cNvGrpSpPr/>
          <p:nvPr/>
        </p:nvGrpSpPr>
        <p:grpSpPr>
          <a:xfrm>
            <a:off x="646468" y="254000"/>
            <a:ext cx="17085907" cy="10776061"/>
            <a:chOff x="646468" y="1365139"/>
            <a:chExt cx="17085907" cy="10776061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11300" y="2235200"/>
              <a:ext cx="16221075" cy="9906000"/>
            </a:xfrm>
            <a:prstGeom prst="rect">
              <a:avLst/>
            </a:prstGeom>
          </p:spPr>
        </p:pic>
        <p:sp>
          <p:nvSpPr>
            <p:cNvPr id="2" name="왼쪽 대괄호 1"/>
            <p:cNvSpPr/>
            <p:nvPr/>
          </p:nvSpPr>
          <p:spPr>
            <a:xfrm>
              <a:off x="1511300" y="2844800"/>
              <a:ext cx="45719" cy="4572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왼쪽 대괄호 4"/>
            <p:cNvSpPr/>
            <p:nvPr/>
          </p:nvSpPr>
          <p:spPr>
            <a:xfrm>
              <a:off x="1515147" y="3454400"/>
              <a:ext cx="45719" cy="2286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" name="왼쪽 대괄호 5"/>
            <p:cNvSpPr/>
            <p:nvPr/>
          </p:nvSpPr>
          <p:spPr>
            <a:xfrm>
              <a:off x="1502422" y="3835400"/>
              <a:ext cx="54597" cy="4191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" name="왼쪽 대괄호 6"/>
            <p:cNvSpPr/>
            <p:nvPr/>
          </p:nvSpPr>
          <p:spPr>
            <a:xfrm>
              <a:off x="1511300" y="8255000"/>
              <a:ext cx="45719" cy="28194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650907" y="2919511"/>
              <a:ext cx="8515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ade III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59785" y="3451423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ade IV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46468" y="5508822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ade I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50168" y="9166423"/>
              <a:ext cx="8018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ade II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그룹 13"/>
            <p:cNvGrpSpPr/>
            <p:nvPr/>
          </p:nvGrpSpPr>
          <p:grpSpPr>
            <a:xfrm>
              <a:off x="4305986" y="1854200"/>
              <a:ext cx="1752600" cy="381000"/>
              <a:chOff x="4305986" y="1854200"/>
              <a:chExt cx="1752600" cy="381000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4527837" y="1866557"/>
                <a:ext cx="12795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HC I HS 1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직사각형 12"/>
              <p:cNvSpPr/>
              <p:nvPr/>
            </p:nvSpPr>
            <p:spPr>
              <a:xfrm>
                <a:off x="4305986" y="1854200"/>
                <a:ext cx="1752600" cy="381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15" name="그룹 14"/>
            <p:cNvGrpSpPr/>
            <p:nvPr/>
          </p:nvGrpSpPr>
          <p:grpSpPr>
            <a:xfrm>
              <a:off x="11569704" y="1866557"/>
              <a:ext cx="3276602" cy="368643"/>
              <a:chOff x="4305986" y="1854200"/>
              <a:chExt cx="1752600" cy="381000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4686024" y="1866557"/>
                <a:ext cx="993109" cy="3499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HC I HS 2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직사각형 16"/>
              <p:cNvSpPr/>
              <p:nvPr/>
            </p:nvSpPr>
            <p:spPr>
              <a:xfrm>
                <a:off x="4305986" y="1854200"/>
                <a:ext cx="1752600" cy="381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18" name="그룹 17"/>
            <p:cNvGrpSpPr/>
            <p:nvPr/>
          </p:nvGrpSpPr>
          <p:grpSpPr>
            <a:xfrm>
              <a:off x="15697821" y="1854201"/>
              <a:ext cx="1434479" cy="381000"/>
              <a:chOff x="4305986" y="1854200"/>
              <a:chExt cx="1752600" cy="381000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4403699" y="1867058"/>
                <a:ext cx="156327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HC I HS 3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직사각형 19"/>
              <p:cNvSpPr/>
              <p:nvPr/>
            </p:nvSpPr>
            <p:spPr>
              <a:xfrm>
                <a:off x="4305986" y="1854200"/>
                <a:ext cx="1752600" cy="381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24" name="그룹 23"/>
            <p:cNvGrpSpPr/>
            <p:nvPr/>
          </p:nvGrpSpPr>
          <p:grpSpPr>
            <a:xfrm>
              <a:off x="4635500" y="1365139"/>
              <a:ext cx="2023369" cy="434258"/>
              <a:chOff x="4650460" y="839890"/>
              <a:chExt cx="2023369" cy="434258"/>
            </a:xfrm>
          </p:grpSpPr>
          <p:sp>
            <p:nvSpPr>
              <p:cNvPr id="23" name="직사각형 22"/>
              <p:cNvSpPr/>
              <p:nvPr/>
            </p:nvSpPr>
            <p:spPr>
              <a:xfrm>
                <a:off x="4650460" y="839890"/>
                <a:ext cx="2023369" cy="43425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938242" y="888314"/>
                <a:ext cx="1464289" cy="33855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HC II HS 1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5" name="TextBox 24"/>
          <p:cNvSpPr txBox="1"/>
          <p:nvPr/>
        </p:nvSpPr>
        <p:spPr>
          <a:xfrm>
            <a:off x="646468" y="11179484"/>
            <a:ext cx="1636858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</a:t>
            </a:r>
            <a:r>
              <a:rPr lang="en-US" altLang="ko-KR" dirty="0" smtClean="0"/>
              <a:t>S1. </a:t>
            </a:r>
            <a:r>
              <a:rPr lang="en-US" altLang="ko-KR" dirty="0" smtClean="0"/>
              <a:t>Representation of the amino acid sequence variation in the E2 region across 44 representative sequence types. These illustrations were generated </a:t>
            </a:r>
          </a:p>
          <a:p>
            <a:r>
              <a:rPr lang="en-US" altLang="ko-KR" dirty="0" smtClean="0"/>
              <a:t>by </a:t>
            </a:r>
            <a:r>
              <a:rPr lang="en-US" altLang="ko-KR" sz="1800" dirty="0" err="1" smtClean="0"/>
              <a:t>megalign</a:t>
            </a:r>
            <a:r>
              <a:rPr lang="en-US" altLang="ko-KR" sz="1800" dirty="0" smtClean="0"/>
              <a:t> </a:t>
            </a:r>
            <a:r>
              <a:rPr lang="en-US" altLang="ko-KR" sz="1800" dirty="0"/>
              <a:t>pro software (</a:t>
            </a:r>
            <a:r>
              <a:rPr lang="en-US" altLang="ko-KR" sz="1800" dirty="0" err="1"/>
              <a:t>Dnastar</a:t>
            </a:r>
            <a:r>
              <a:rPr lang="en-US" altLang="ko-KR" sz="1800" dirty="0"/>
              <a:t> Inc</a:t>
            </a:r>
            <a:r>
              <a:rPr lang="en-US" altLang="ko-KR" sz="1800" dirty="0" smtClean="0"/>
              <a:t>.). Variations from the consensus sequence are highlighted with colored letters. </a:t>
            </a:r>
          </a:p>
          <a:p>
            <a:r>
              <a:rPr lang="en-US" altLang="ko-KR" dirty="0" smtClean="0"/>
              <a:t>Hotspot (HS) regions for MHC molecules are also annotated, corresponding to their positions in the sequences above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35057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그룹 18"/>
          <p:cNvGrpSpPr/>
          <p:nvPr/>
        </p:nvGrpSpPr>
        <p:grpSpPr>
          <a:xfrm>
            <a:off x="368300" y="1016000"/>
            <a:ext cx="17370922" cy="9947188"/>
            <a:chOff x="447178" y="2041612"/>
            <a:chExt cx="17370922" cy="9947188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87475" y="2463800"/>
              <a:ext cx="16430625" cy="9525000"/>
            </a:xfrm>
            <a:prstGeom prst="rect">
              <a:avLst/>
            </a:prstGeom>
          </p:spPr>
        </p:pic>
        <p:grpSp>
          <p:nvGrpSpPr>
            <p:cNvPr id="11" name="그룹 10"/>
            <p:cNvGrpSpPr/>
            <p:nvPr/>
          </p:nvGrpSpPr>
          <p:grpSpPr>
            <a:xfrm>
              <a:off x="447178" y="3032712"/>
              <a:ext cx="940297" cy="7965488"/>
              <a:chOff x="368300" y="2499312"/>
              <a:chExt cx="940297" cy="7965488"/>
            </a:xfrm>
          </p:grpSpPr>
          <p:sp>
            <p:nvSpPr>
              <p:cNvPr id="3" name="왼쪽 대괄호 2"/>
              <p:cNvSpPr/>
              <p:nvPr/>
            </p:nvSpPr>
            <p:spPr>
              <a:xfrm>
                <a:off x="1233132" y="2499312"/>
                <a:ext cx="45719" cy="4572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" name="왼쪽 대괄호 3"/>
              <p:cNvSpPr/>
              <p:nvPr/>
            </p:nvSpPr>
            <p:spPr>
              <a:xfrm>
                <a:off x="1236979" y="3108912"/>
                <a:ext cx="45719" cy="2286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" name="왼쪽 대괄호 4"/>
              <p:cNvSpPr/>
              <p:nvPr/>
            </p:nvSpPr>
            <p:spPr>
              <a:xfrm>
                <a:off x="1224254" y="3489912"/>
                <a:ext cx="84343" cy="40386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" name="왼쪽 대괄호 5"/>
              <p:cNvSpPr/>
              <p:nvPr/>
            </p:nvSpPr>
            <p:spPr>
              <a:xfrm>
                <a:off x="1233132" y="7721600"/>
                <a:ext cx="75465" cy="27432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72739" y="2574023"/>
                <a:ext cx="85151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lade III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81617" y="3105935"/>
                <a:ext cx="8723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lade IV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68300" y="5163334"/>
                <a:ext cx="75212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lade I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72000" y="8820935"/>
                <a:ext cx="80182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lade II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그룹 12"/>
            <p:cNvGrpSpPr/>
            <p:nvPr/>
          </p:nvGrpSpPr>
          <p:grpSpPr>
            <a:xfrm>
              <a:off x="4052672" y="2041612"/>
              <a:ext cx="3021228" cy="422187"/>
              <a:chOff x="4305986" y="1854200"/>
              <a:chExt cx="1752600" cy="381000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4796475" y="1866557"/>
                <a:ext cx="742242" cy="30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HC I HS 4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직사각형 14"/>
              <p:cNvSpPr/>
              <p:nvPr/>
            </p:nvSpPr>
            <p:spPr>
              <a:xfrm>
                <a:off x="4305986" y="1854200"/>
                <a:ext cx="1752600" cy="381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16" name="그룹 15"/>
            <p:cNvGrpSpPr/>
            <p:nvPr/>
          </p:nvGrpSpPr>
          <p:grpSpPr>
            <a:xfrm>
              <a:off x="12407900" y="2055306"/>
              <a:ext cx="2362200" cy="408494"/>
              <a:chOff x="4305986" y="1854200"/>
              <a:chExt cx="1752600" cy="381000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4692937" y="1866557"/>
                <a:ext cx="949319" cy="3157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HC I HS 5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직사각형 17"/>
              <p:cNvSpPr/>
              <p:nvPr/>
            </p:nvSpPr>
            <p:spPr>
              <a:xfrm>
                <a:off x="4305986" y="1854200"/>
                <a:ext cx="1752600" cy="381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  <p:sp>
        <p:nvSpPr>
          <p:cNvPr id="20" name="TextBox 19"/>
          <p:cNvSpPr txBox="1"/>
          <p:nvPr/>
        </p:nvSpPr>
        <p:spPr>
          <a:xfrm>
            <a:off x="646468" y="11179484"/>
            <a:ext cx="2428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</a:t>
            </a:r>
            <a:r>
              <a:rPr lang="en-US" altLang="ko-KR" dirty="0" smtClean="0"/>
              <a:t>S1. </a:t>
            </a:r>
            <a:r>
              <a:rPr lang="en-US" altLang="ko-KR" dirty="0" smtClean="0"/>
              <a:t>Continued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217972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995" y="1274368"/>
            <a:ext cx="16814483" cy="9677400"/>
          </a:xfrm>
          <a:prstGeom prst="rect">
            <a:avLst/>
          </a:prstGeom>
        </p:spPr>
      </p:pic>
      <p:grpSp>
        <p:nvGrpSpPr>
          <p:cNvPr id="3" name="그룹 2"/>
          <p:cNvGrpSpPr/>
          <p:nvPr/>
        </p:nvGrpSpPr>
        <p:grpSpPr>
          <a:xfrm>
            <a:off x="292100" y="1892708"/>
            <a:ext cx="940297" cy="7965488"/>
            <a:chOff x="368300" y="2499312"/>
            <a:chExt cx="940297" cy="7965488"/>
          </a:xfrm>
        </p:grpSpPr>
        <p:sp>
          <p:nvSpPr>
            <p:cNvPr id="4" name="왼쪽 대괄호 3"/>
            <p:cNvSpPr/>
            <p:nvPr/>
          </p:nvSpPr>
          <p:spPr>
            <a:xfrm>
              <a:off x="1233132" y="2499312"/>
              <a:ext cx="45719" cy="4572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왼쪽 대괄호 4"/>
            <p:cNvSpPr/>
            <p:nvPr/>
          </p:nvSpPr>
          <p:spPr>
            <a:xfrm>
              <a:off x="1236979" y="3108912"/>
              <a:ext cx="45719" cy="2286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" name="왼쪽 대괄호 5"/>
            <p:cNvSpPr/>
            <p:nvPr/>
          </p:nvSpPr>
          <p:spPr>
            <a:xfrm>
              <a:off x="1224254" y="3489912"/>
              <a:ext cx="84343" cy="40386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" name="왼쪽 대괄호 6"/>
            <p:cNvSpPr/>
            <p:nvPr/>
          </p:nvSpPr>
          <p:spPr>
            <a:xfrm>
              <a:off x="1233132" y="7721600"/>
              <a:ext cx="75465" cy="27432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72739" y="2574023"/>
              <a:ext cx="8515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ade III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81617" y="3105935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ade IV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68300" y="5163334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ade I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72000" y="8820935"/>
              <a:ext cx="8018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ade II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그룹 11"/>
          <p:cNvGrpSpPr/>
          <p:nvPr/>
        </p:nvGrpSpPr>
        <p:grpSpPr>
          <a:xfrm>
            <a:off x="4052672" y="852180"/>
            <a:ext cx="2716428" cy="422188"/>
            <a:chOff x="4305986" y="1854200"/>
            <a:chExt cx="1752600" cy="381000"/>
          </a:xfrm>
        </p:grpSpPr>
        <p:sp>
          <p:nvSpPr>
            <p:cNvPr id="13" name="TextBox 12"/>
            <p:cNvSpPr txBox="1"/>
            <p:nvPr/>
          </p:nvSpPr>
          <p:spPr>
            <a:xfrm>
              <a:off x="4754833" y="1866557"/>
              <a:ext cx="825526" cy="3055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HC I HS 6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직사각형 13"/>
            <p:cNvSpPr/>
            <p:nvPr/>
          </p:nvSpPr>
          <p:spPr>
            <a:xfrm>
              <a:off x="4305986" y="1854200"/>
              <a:ext cx="1752600" cy="38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5" name="그룹 14"/>
          <p:cNvGrpSpPr/>
          <p:nvPr/>
        </p:nvGrpSpPr>
        <p:grpSpPr>
          <a:xfrm>
            <a:off x="7531100" y="852180"/>
            <a:ext cx="5181600" cy="424245"/>
            <a:chOff x="4305986" y="1854200"/>
            <a:chExt cx="1752600" cy="381000"/>
          </a:xfrm>
        </p:grpSpPr>
        <p:sp>
          <p:nvSpPr>
            <p:cNvPr id="16" name="TextBox 15"/>
            <p:cNvSpPr txBox="1"/>
            <p:nvPr/>
          </p:nvSpPr>
          <p:spPr>
            <a:xfrm>
              <a:off x="4951207" y="1866557"/>
              <a:ext cx="432778" cy="3040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HC I HS 7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직사각형 16"/>
            <p:cNvSpPr/>
            <p:nvPr/>
          </p:nvSpPr>
          <p:spPr>
            <a:xfrm>
              <a:off x="4305986" y="1854200"/>
              <a:ext cx="1752600" cy="38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8" name="그룹 17"/>
          <p:cNvGrpSpPr/>
          <p:nvPr/>
        </p:nvGrpSpPr>
        <p:grpSpPr>
          <a:xfrm>
            <a:off x="15608300" y="852180"/>
            <a:ext cx="1905000" cy="422188"/>
            <a:chOff x="4305986" y="1854200"/>
            <a:chExt cx="1752600" cy="381000"/>
          </a:xfrm>
        </p:grpSpPr>
        <p:sp>
          <p:nvSpPr>
            <p:cNvPr id="19" name="TextBox 18"/>
            <p:cNvSpPr txBox="1"/>
            <p:nvPr/>
          </p:nvSpPr>
          <p:spPr>
            <a:xfrm>
              <a:off x="4579018" y="1866557"/>
              <a:ext cx="1177156" cy="3055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HC I HS 8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직사각형 19"/>
            <p:cNvSpPr/>
            <p:nvPr/>
          </p:nvSpPr>
          <p:spPr>
            <a:xfrm>
              <a:off x="4305986" y="1854200"/>
              <a:ext cx="1752600" cy="38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4" name="그룹 23"/>
          <p:cNvGrpSpPr/>
          <p:nvPr/>
        </p:nvGrpSpPr>
        <p:grpSpPr>
          <a:xfrm>
            <a:off x="10628528" y="330200"/>
            <a:ext cx="2388972" cy="452106"/>
            <a:chOff x="4650460" y="839890"/>
            <a:chExt cx="2023369" cy="434258"/>
          </a:xfrm>
        </p:grpSpPr>
        <p:sp>
          <p:nvSpPr>
            <p:cNvPr id="25" name="직사각형 24"/>
            <p:cNvSpPr/>
            <p:nvPr/>
          </p:nvSpPr>
          <p:spPr>
            <a:xfrm>
              <a:off x="4650460" y="839890"/>
              <a:ext cx="2023369" cy="43425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938242" y="888314"/>
              <a:ext cx="1464289" cy="32518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HC II HS 2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646468" y="11179484"/>
            <a:ext cx="2428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Figure </a:t>
            </a:r>
            <a:r>
              <a:rPr lang="en-US" altLang="ko-KR" smtClean="0"/>
              <a:t>S1. </a:t>
            </a:r>
            <a:r>
              <a:rPr lang="en-US" altLang="ko-KR" dirty="0" smtClean="0"/>
              <a:t>Continued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28310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</TotalTime>
  <Words>138</Words>
  <Application>Microsoft Office PowerPoint</Application>
  <PresentationFormat>사용자 지정</PresentationFormat>
  <Paragraphs>27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Calibri</vt:lpstr>
      <vt:lpstr>Office Theme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백신바이오연구소</dc:creator>
  <cp:lastModifiedBy>백신바이오연구소</cp:lastModifiedBy>
  <cp:revision>10</cp:revision>
  <dcterms:created xsi:type="dcterms:W3CDTF">2024-10-18T08:10:17Z</dcterms:created>
  <dcterms:modified xsi:type="dcterms:W3CDTF">2024-10-21T06:09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4-10-18T00:00:00Z</vt:filetime>
  </property>
  <property fmtid="{D5CDD505-2E9C-101B-9397-08002B2CF9AE}" pid="3" name="Creator">
    <vt:lpwstr>Adobe Acrobat Pro (64-bit) 24.3.20180</vt:lpwstr>
  </property>
  <property fmtid="{D5CDD505-2E9C-101B-9397-08002B2CF9AE}" pid="4" name="LastSaved">
    <vt:filetime>2024-10-18T00:00:00Z</vt:filetime>
  </property>
  <property fmtid="{D5CDD505-2E9C-101B-9397-08002B2CF9AE}" pid="5" name="Producer">
    <vt:lpwstr>Adobe Acrobat Pro (64-bit) 24.3.20180</vt:lpwstr>
  </property>
</Properties>
</file>